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92" d="100"/>
          <a:sy n="92" d="100"/>
        </p:scale>
        <p:origin x="72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字幕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38609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54021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6221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87087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7874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57483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46289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1086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32383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9405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55381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8981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AD46369-8431-4C06-A527-93C9BFB49CC9}"/>
              </a:ext>
            </a:extLst>
          </p:cNvPr>
          <p:cNvSpPr txBox="1"/>
          <p:nvPr/>
        </p:nvSpPr>
        <p:spPr>
          <a:xfrm>
            <a:off x="6248400" y="6595110"/>
            <a:ext cx="2918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ditional file 1 (Muraki and Hirota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33F9C442-31DE-4AC1-8831-9DC5E07E1F3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241" y="1832841"/>
            <a:ext cx="3749826" cy="3215409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7BC1CEE-1F98-4492-9CE3-DDA169E65FEE}"/>
              </a:ext>
            </a:extLst>
          </p:cNvPr>
          <p:cNvSpPr txBox="1"/>
          <p:nvPr/>
        </p:nvSpPr>
        <p:spPr>
          <a:xfrm>
            <a:off x="5029200" y="1916732"/>
            <a:ext cx="2628900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Additional file 1.  Size-exclusion chromatography profile of the hFasLECD-Avi conjugate sample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40</a:t>
            </a:r>
            <a:r>
              <a:rPr lang="en-US" altLang="ja-JP" sz="1400" dirty="0"/>
              <a:t> </a:t>
            </a:r>
            <a:r>
              <a:rPr lang="en-US" altLang="ja-JP" sz="1400" dirty="0">
                <a:latin typeface="Symbol" panose="05050102010706020507" pitchFamily="18" charset="2"/>
              </a:rPr>
              <a:t>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 of the sample was resolved using a Superdex 200 Increase 10/300 GL column (GE healthcare) under the conditions of 50 mM Tris-HCl plus 150 mM NaCl (pH 7.5) as the elution buffer and flow rate of 0.75 ml / min. Absorbance at 280 nm was used for the peak detection</a:t>
            </a:r>
            <a:r>
              <a:rPr lang="en-US" altLang="ja-JP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018660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79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木三智郎</dc:creator>
  <cp:lastModifiedBy>村木 三智郎</cp:lastModifiedBy>
  <cp:revision>31</cp:revision>
  <cp:lastPrinted>2018-04-16T11:35:34Z</cp:lastPrinted>
  <dcterms:created xsi:type="dcterms:W3CDTF">2018-03-26T02:22:14Z</dcterms:created>
  <dcterms:modified xsi:type="dcterms:W3CDTF">2018-04-26T23:39:41Z</dcterms:modified>
</cp:coreProperties>
</file>